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9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5" d="100"/>
          <a:sy n="95" d="100"/>
        </p:scale>
        <p:origin x="-1566" y="-3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320800" y="1547664"/>
          <a:ext cx="4216400" cy="741680"/>
        </p:xfrm>
        <a:graphic>
          <a:graphicData uri="http://schemas.openxmlformats.org/drawingml/2006/table">
            <a:tbl>
              <a:tblPr/>
              <a:tblGrid>
                <a:gridCol w="863600"/>
                <a:gridCol w="1549400"/>
                <a:gridCol w="1803400"/>
              </a:tblGrid>
              <a:tr h="370840">
                <a:tc>
                  <a:txBody>
                    <a:bodyPr/>
                    <a:lstStyle/>
                    <a:p>
                      <a:endParaRPr lang="it-IT" sz="1100">
                        <a:solidFill>
                          <a:srgbClr val="000000"/>
                        </a:solidFill>
                        <a:latin typeface="Calibri Ligh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000" b="1" kern="120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siNEG</a:t>
                      </a:r>
                      <a:endParaRPr lang="it-IT" sz="11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6F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000" b="1" kern="120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siGDF-15 </a:t>
                      </a:r>
                      <a:endParaRPr lang="it-IT" sz="11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6F6"/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000" kern="120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GDF-15</a:t>
                      </a:r>
                      <a:endParaRPr lang="it-IT" sz="11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000" kern="120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1</a:t>
                      </a:r>
                      <a:endParaRPr lang="it-IT" sz="11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2D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000" kern="12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0.03</a:t>
                      </a:r>
                      <a:endParaRPr lang="it-IT" sz="11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2D2"/>
                    </a:solidFill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-98661"/>
            <a:ext cx="6858000" cy="13849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152352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S</a:t>
            </a:r>
            <a:r>
              <a:rPr kumimoji="0" lang="en-US" sz="16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upplementary table</a:t>
            </a:r>
            <a:endParaRPr kumimoji="0" lang="en-GB" sz="1600" b="0" i="0" u="none" strike="noStrike" cap="none" normalizeH="0" baseline="0" dirty="0" smtClean="0" bmk="">
              <a:ln>
                <a:noFill/>
              </a:ln>
              <a:solidFill>
                <a:srgbClr val="2E74B5"/>
              </a:solidFill>
              <a:effectLst/>
              <a:latin typeface="Calibri Light" pitchFamily="34" charset="0"/>
              <a:ea typeface="Times New Roman" pitchFamily="18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upplementary Table 1.</a:t>
            </a: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Quantification of band intensities for blot reported in Figure 2D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. Quantification was performed using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ImageJ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Arial" pitchFamily="34" charset="0"/>
              </a:rPr>
              <a:t>1.47q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oftware. After normalization to corresponding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vinculin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, normalized value for treated (siGDF-15) sample was compared to the corresponding band of the control (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iNEG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) sample.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58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valentina</cp:lastModifiedBy>
  <cp:revision>12</cp:revision>
  <dcterms:created xsi:type="dcterms:W3CDTF">2024-08-02T07:16:01Z</dcterms:created>
  <dcterms:modified xsi:type="dcterms:W3CDTF">2024-08-02T07:37:02Z</dcterms:modified>
</cp:coreProperties>
</file>